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9" d="100"/>
          <a:sy n="69" d="100"/>
        </p:scale>
        <p:origin x="-600" y="-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1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1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1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1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1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19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19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19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19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19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19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4/1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Fig. S1.png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0" y="533400"/>
            <a:ext cx="9144000" cy="4114800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304800" y="5257800"/>
            <a:ext cx="849444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dirty="0" smtClean="0"/>
              <a:t>Fig. S1. Rarefaction curves in different  groups based on observed richness after removal </a:t>
            </a:r>
          </a:p>
          <a:p>
            <a:r>
              <a:rPr lang="en-IN" dirty="0" smtClean="0"/>
              <a:t>of OTUs appearing only once and after rarefying data to minimum </a:t>
            </a:r>
            <a:r>
              <a:rPr lang="en-IN" smtClean="0"/>
              <a:t>library size</a:t>
            </a:r>
            <a:endParaRPr lang="en-IN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8</Words>
  <Application>Microsoft Office PowerPoint</Application>
  <PresentationFormat>On-screen Show 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Shyam</dc:creator>
  <cp:lastModifiedBy>Shyam</cp:lastModifiedBy>
  <cp:revision>1</cp:revision>
  <dcterms:created xsi:type="dcterms:W3CDTF">2006-08-16T00:00:00Z</dcterms:created>
  <dcterms:modified xsi:type="dcterms:W3CDTF">2023-04-19T11:33:14Z</dcterms:modified>
</cp:coreProperties>
</file>